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5E1ED-3A6B-305E-1C1D-3478D3338C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DA555B-C8F2-3AC1-9B41-2FE4CD4BEF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A03E18-6D7F-D371-88C6-CB77460ED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A62EE-F76E-220D-27CF-991F1EABA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FC03D-264E-AB76-4C3D-FFC648649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438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AD856-B635-2935-F280-0A9600BEDF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9883A0-EE49-E66D-B659-7EEAE2631E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258DA-F0DF-3C9A-6E06-BBE3722B1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CCB8FD-6E6B-B151-9236-6E095ABAE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67E586-58A9-88CE-7DE5-74F747D1A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0866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004893-AEA6-D9B5-743C-8134325178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8B1B9-805F-2469-5BDE-B6386BAF20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6AD294-9555-9440-5569-F7A2C60CE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13F7D-AD7F-EA26-8645-7A2ECA00F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EE3A34-FD88-9951-7400-2877D264C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625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6B449-8A4D-CCD6-9C61-D86C30D8B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8B0F38-F06D-C1B2-411A-57AED69C81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2CF27-4F82-DD0F-C7AD-DBFC70EAE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7DE84-8DB6-4519-F5B9-51291D2B9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10289E-3709-F9B8-19CC-BE171414D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925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3998FF-69A7-3C0E-6170-005DFDBC5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631F41-4DC8-BC26-33E1-F6E60FAE7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B3CD7-2E5E-C70B-0D9B-3D8B0F4DA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459EB-E4AB-3B2E-E622-13CE27CB3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0B10A8-C5BC-37AB-2EEB-41C6C4912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232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9F633-6B86-4CD0-F818-EB2606D24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733642-4039-72E2-10D4-0F9E496204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41F8D8-D098-FC93-4CB6-0DBB0BB1BB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636D30-D3A6-1AE8-7140-17531BAC3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7A93E0-837E-B905-F297-06AA9D4E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3FC576-7111-A37B-7F5D-97A3A04CD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339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3F8D8-CB6D-D43F-8D86-687481AC7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DC9441-FE0E-83F0-E384-35944A19F5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79E23F-BB73-BE62-6310-41B9527DDC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EAF05E-6054-19AC-FAD5-AEED46A9CE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B7C715-5E55-85F8-DD93-6FAB149975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69D3B7-0C72-2EC1-185D-7018BE87C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ECAC12-8BFC-880D-55B1-BE0143000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4FD8CB-3A23-EFF4-7F45-64EEC1EC4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325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6F01D-B149-4BDA-3A43-752CD225E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00949B-CAC6-D0A7-A718-97EA1BA81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E16AF2-3671-6B19-2791-83E70D94C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3E8BEC-9793-8224-6542-70DA28017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36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C3F0C1-9DAD-7317-189C-20558D722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FFA4E1-4AB4-A05F-EA14-9BD7361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322005-B0DD-CF7C-AAFF-86F18761D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214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D0D88-6FBC-37E4-A2F2-35B0BF7D2B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EA8955-A425-994C-9A14-0591E7DD0F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CDF700-6686-1936-816D-E865B8C126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C6F49-F2F8-CF07-79E5-D940BF8EC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F46E23-E3BF-9065-3A07-FB2A2654B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2F14E2-0C36-0A64-4854-0BBFD9911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810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EEEBF3-AC5A-CC36-F8FA-18608816B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FAF7F1-9015-3857-A378-CAD4D36F50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6C074-0D6C-9BF4-2DA2-8D5620CB3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92C74B-0D06-E8D8-931E-B0F2A845C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777B2A-4950-6901-2F34-9B8D7789C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3EE92-1EAE-4F42-3949-D3D3B175A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537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F17703-EF16-0A57-9D28-865BC376FC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0599EE-F48E-8692-549B-FB6EACA127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C1382-64B4-99B7-3864-52F5EE9304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C500C8-F443-5985-CBA5-E69CD8E70A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5B4593-ACC1-FD5C-DAE0-7751404EAB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979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EA1BA354-3436-5C37-8115-3A7A73A570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750" r="3410"/>
          <a:stretch/>
        </p:blipFill>
        <p:spPr>
          <a:xfrm>
            <a:off x="1773799" y="2083200"/>
            <a:ext cx="3013241" cy="419056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93C2B34-5357-E468-3CF6-B6869C02A248}"/>
              </a:ext>
            </a:extLst>
          </p:cNvPr>
          <p:cNvSpPr txBox="1"/>
          <p:nvPr/>
        </p:nvSpPr>
        <p:spPr>
          <a:xfrm>
            <a:off x="885343" y="2191173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AF040A-FB63-0223-D5FC-9F2B92A07329}"/>
              </a:ext>
            </a:extLst>
          </p:cNvPr>
          <p:cNvSpPr txBox="1"/>
          <p:nvPr/>
        </p:nvSpPr>
        <p:spPr>
          <a:xfrm>
            <a:off x="1101533" y="4837301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PX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8E1BEFE-340A-1996-2875-E5943E330984}"/>
              </a:ext>
            </a:extLst>
          </p:cNvPr>
          <p:cNvSpPr txBox="1"/>
          <p:nvPr/>
        </p:nvSpPr>
        <p:spPr>
          <a:xfrm>
            <a:off x="7556246" y="4336398"/>
            <a:ext cx="238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arker exposure/imag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7591414-D7C2-D705-9387-F8E45CD0E00D}"/>
              </a:ext>
            </a:extLst>
          </p:cNvPr>
          <p:cNvSpPr txBox="1"/>
          <p:nvPr/>
        </p:nvSpPr>
        <p:spPr>
          <a:xfrm>
            <a:off x="4787040" y="549128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BC7C4C-BE5B-CDB9-F49C-165A2DEF0D1D}"/>
              </a:ext>
            </a:extLst>
          </p:cNvPr>
          <p:cNvSpPr txBox="1"/>
          <p:nvPr/>
        </p:nvSpPr>
        <p:spPr>
          <a:xfrm>
            <a:off x="4787040" y="502121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8B5977-88D3-5236-7634-D50DE513A696}"/>
              </a:ext>
            </a:extLst>
          </p:cNvPr>
          <p:cNvSpPr txBox="1"/>
          <p:nvPr/>
        </p:nvSpPr>
        <p:spPr>
          <a:xfrm>
            <a:off x="4787039" y="4469583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7B93459-64B0-806B-AA89-41B9CA58FDA5}"/>
              </a:ext>
            </a:extLst>
          </p:cNvPr>
          <p:cNvSpPr txBox="1"/>
          <p:nvPr/>
        </p:nvSpPr>
        <p:spPr>
          <a:xfrm>
            <a:off x="4787039" y="409442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0E844F-32A1-2BC5-64D3-68E36C622EB9}"/>
              </a:ext>
            </a:extLst>
          </p:cNvPr>
          <p:cNvSpPr txBox="1"/>
          <p:nvPr/>
        </p:nvSpPr>
        <p:spPr>
          <a:xfrm>
            <a:off x="4787038" y="371927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D23D6B-C1AD-02E3-0B72-F6537878524A}"/>
              </a:ext>
            </a:extLst>
          </p:cNvPr>
          <p:cNvSpPr txBox="1"/>
          <p:nvPr/>
        </p:nvSpPr>
        <p:spPr>
          <a:xfrm>
            <a:off x="4787037" y="340888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5CE80D-9BB5-EBDF-6497-7918DDDB7C1D}"/>
              </a:ext>
            </a:extLst>
          </p:cNvPr>
          <p:cNvSpPr txBox="1"/>
          <p:nvPr/>
        </p:nvSpPr>
        <p:spPr>
          <a:xfrm>
            <a:off x="4729403" y="2763734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A53FD1E-752F-372F-09FE-681CA07D21AF}"/>
              </a:ext>
            </a:extLst>
          </p:cNvPr>
          <p:cNvSpPr txBox="1"/>
          <p:nvPr/>
        </p:nvSpPr>
        <p:spPr>
          <a:xfrm>
            <a:off x="4766842" y="2380375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3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95A56CE-9C71-7711-1EF5-CB5F0AC77DC5}"/>
              </a:ext>
            </a:extLst>
          </p:cNvPr>
          <p:cNvSpPr txBox="1"/>
          <p:nvPr/>
        </p:nvSpPr>
        <p:spPr>
          <a:xfrm>
            <a:off x="4758222" y="2072363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8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FFF0AA-A9C2-F4A9-78BA-E1D5FC8D2B1B}"/>
              </a:ext>
            </a:extLst>
          </p:cNvPr>
          <p:cNvSpPr txBox="1"/>
          <p:nvPr/>
        </p:nvSpPr>
        <p:spPr>
          <a:xfrm>
            <a:off x="4787036" y="310359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89534B2-B24A-13B7-CC92-8726E4755EAE}"/>
              </a:ext>
            </a:extLst>
          </p:cNvPr>
          <p:cNvSpPr txBox="1"/>
          <p:nvPr/>
        </p:nvSpPr>
        <p:spPr>
          <a:xfrm>
            <a:off x="721908" y="1767855"/>
            <a:ext cx="3647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a2SeO3           +       +       +       -       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3B6B45-726F-69F3-094C-709681A9BA8C}"/>
              </a:ext>
            </a:extLst>
          </p:cNvPr>
          <p:cNvSpPr txBox="1"/>
          <p:nvPr/>
        </p:nvSpPr>
        <p:spPr>
          <a:xfrm rot="16200000">
            <a:off x="1682152" y="1062975"/>
            <a:ext cx="1164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SEPSECS</a:t>
            </a:r>
            <a:endParaRPr lang="en-GB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74853B-1232-807B-6D2F-03C1B98E63A3}"/>
              </a:ext>
            </a:extLst>
          </p:cNvPr>
          <p:cNvSpPr txBox="1"/>
          <p:nvPr/>
        </p:nvSpPr>
        <p:spPr>
          <a:xfrm rot="16200000">
            <a:off x="2373854" y="122593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PSTK</a:t>
            </a:r>
            <a:endParaRPr lang="en-GB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1A56DB-6BB3-E3DF-64A2-0D81968704CA}"/>
              </a:ext>
            </a:extLst>
          </p:cNvPr>
          <p:cNvSpPr txBox="1"/>
          <p:nvPr/>
        </p:nvSpPr>
        <p:spPr>
          <a:xfrm rot="16200000">
            <a:off x="2736840" y="1101704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gSEPSH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BE649C5-24BE-FD90-C9CF-C6813C444377}"/>
              </a:ext>
            </a:extLst>
          </p:cNvPr>
          <p:cNvSpPr txBox="1"/>
          <p:nvPr/>
        </p:nvSpPr>
        <p:spPr>
          <a:xfrm rot="16200000">
            <a:off x="3672819" y="1362962"/>
            <a:ext cx="56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0613E677-8173-C02D-7A01-3CF0D3F28D7D}"/>
              </a:ext>
            </a:extLst>
          </p:cNvPr>
          <p:cNvCxnSpPr/>
          <p:nvPr/>
        </p:nvCxnSpPr>
        <p:spPr>
          <a:xfrm>
            <a:off x="3644745" y="1854117"/>
            <a:ext cx="62078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43">
            <a:extLst>
              <a:ext uri="{FF2B5EF4-FFF2-40B4-BE49-F238E27FC236}">
                <a16:creationId xmlns:a16="http://schemas.microsoft.com/office/drawing/2014/main" id="{577151CA-9623-D53A-4A99-2654288C63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40914" y="3257415"/>
            <a:ext cx="3013241" cy="99990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8D4B8783-2265-04CF-73B9-F2B41700009D}"/>
              </a:ext>
            </a:extLst>
          </p:cNvPr>
          <p:cNvSpPr txBox="1"/>
          <p:nvPr/>
        </p:nvSpPr>
        <p:spPr>
          <a:xfrm>
            <a:off x="6330084" y="3441266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1BFEF8A-1E9C-CEA4-7EA9-956A9CE68E1E}"/>
              </a:ext>
            </a:extLst>
          </p:cNvPr>
          <p:cNvSpPr txBox="1"/>
          <p:nvPr/>
        </p:nvSpPr>
        <p:spPr>
          <a:xfrm>
            <a:off x="10254151" y="3964306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ADA4705-AB23-6D44-08A1-E5A5CBF06F85}"/>
              </a:ext>
            </a:extLst>
          </p:cNvPr>
          <p:cNvSpPr txBox="1"/>
          <p:nvPr/>
        </p:nvSpPr>
        <p:spPr>
          <a:xfrm>
            <a:off x="10254152" y="3548972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3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A135746-C6BE-B86B-9E5A-4C75DE3F6DB9}"/>
              </a:ext>
            </a:extLst>
          </p:cNvPr>
          <p:cNvSpPr txBox="1"/>
          <p:nvPr/>
        </p:nvSpPr>
        <p:spPr>
          <a:xfrm>
            <a:off x="10254155" y="3254368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8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06F6581-6B30-E2F7-1430-CB1EDC0DD141}"/>
              </a:ext>
            </a:extLst>
          </p:cNvPr>
          <p:cNvSpPr txBox="1"/>
          <p:nvPr/>
        </p:nvSpPr>
        <p:spPr>
          <a:xfrm>
            <a:off x="6068899" y="2916809"/>
            <a:ext cx="3647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a2SeO3           +       +       +       -       +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F9713C0-30AA-E7C3-A43D-E906CB88AA71}"/>
              </a:ext>
            </a:extLst>
          </p:cNvPr>
          <p:cNvSpPr txBox="1"/>
          <p:nvPr/>
        </p:nvSpPr>
        <p:spPr>
          <a:xfrm rot="16200000">
            <a:off x="7029143" y="2211929"/>
            <a:ext cx="1164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SEPSECS</a:t>
            </a:r>
            <a:endParaRPr lang="en-GB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59ED2BB-F284-1554-E207-B9348DED1BE7}"/>
              </a:ext>
            </a:extLst>
          </p:cNvPr>
          <p:cNvSpPr txBox="1"/>
          <p:nvPr/>
        </p:nvSpPr>
        <p:spPr>
          <a:xfrm rot="16200000">
            <a:off x="7720845" y="2374891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PSTK</a:t>
            </a:r>
            <a:endParaRPr lang="en-GB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06E7B4D-947E-8E57-018E-EA40013A527A}"/>
              </a:ext>
            </a:extLst>
          </p:cNvPr>
          <p:cNvSpPr txBox="1"/>
          <p:nvPr/>
        </p:nvSpPr>
        <p:spPr>
          <a:xfrm rot="16200000">
            <a:off x="8083831" y="2250658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gSEPSH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1D6E5BE-F15C-A4E9-8605-F0E43520949D}"/>
              </a:ext>
            </a:extLst>
          </p:cNvPr>
          <p:cNvSpPr txBox="1"/>
          <p:nvPr/>
        </p:nvSpPr>
        <p:spPr>
          <a:xfrm rot="16200000">
            <a:off x="9019810" y="2511916"/>
            <a:ext cx="56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55D5A29-2E67-9027-32D1-78F30BE763AE}"/>
              </a:ext>
            </a:extLst>
          </p:cNvPr>
          <p:cNvCxnSpPr/>
          <p:nvPr/>
        </p:nvCxnSpPr>
        <p:spPr>
          <a:xfrm>
            <a:off x="8991736" y="3003071"/>
            <a:ext cx="62078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069940D5-6D77-4165-5E29-CE0B3AC094F4}"/>
              </a:ext>
            </a:extLst>
          </p:cNvPr>
          <p:cNvSpPr/>
          <p:nvPr/>
        </p:nvSpPr>
        <p:spPr>
          <a:xfrm>
            <a:off x="1804472" y="4767469"/>
            <a:ext cx="2646434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FFBD928-F6B1-F117-C3AC-1B75B0AC3664}"/>
              </a:ext>
            </a:extLst>
          </p:cNvPr>
          <p:cNvSpPr/>
          <p:nvPr/>
        </p:nvSpPr>
        <p:spPr>
          <a:xfrm rot="175704">
            <a:off x="7315015" y="3414397"/>
            <a:ext cx="2484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31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53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Ackermann</dc:creator>
  <cp:lastModifiedBy>Tobias Ackermann</cp:lastModifiedBy>
  <cp:revision>4</cp:revision>
  <dcterms:created xsi:type="dcterms:W3CDTF">2023-12-14T20:00:16Z</dcterms:created>
  <dcterms:modified xsi:type="dcterms:W3CDTF">2024-07-16T18:33:46Z</dcterms:modified>
</cp:coreProperties>
</file>